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8" r:id="rId2"/>
  </p:sldIdLst>
  <p:sldSz cx="6858000" cy="9906000" type="A4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639" autoAdjust="0"/>
    <p:restoredTop sz="94660"/>
  </p:normalViewPr>
  <p:slideViewPr>
    <p:cSldViewPr snapToGrid="0">
      <p:cViewPr varScale="1">
        <p:scale>
          <a:sx n="73" d="100"/>
          <a:sy n="73" d="100"/>
        </p:scale>
        <p:origin x="243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27B088-4977-458E-83CB-9845DCDA4924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1DADD5-FAE0-4D3B-83C0-6FEBD756C033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4681358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EBE6CE-D66B-43CE-913C-80D055B2D41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C300E2-8266-416D-B540-1E2178BC5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362032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C300E2-8266-416D-B540-1E2178BC51DB}" type="slidenum">
              <a:rPr lang="fr-CH" smtClean="0"/>
              <a:t>1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589047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8911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75963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46655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886538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698765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101565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32110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207970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12040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96652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41867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3468C-B964-43DB-BF5D-AAF213C90BBB}" type="datetimeFigureOut">
              <a:rPr lang="fr-CH" smtClean="0"/>
              <a:t>11.03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08FC1-17F5-429D-AFE1-2E216B7DD87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43678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/>
          <p:cNvGrpSpPr/>
          <p:nvPr/>
        </p:nvGrpSpPr>
        <p:grpSpPr>
          <a:xfrm>
            <a:off x="814263" y="815496"/>
            <a:ext cx="5328779" cy="3553633"/>
            <a:chOff x="710446" y="5310967"/>
            <a:chExt cx="5628573" cy="3753558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10446" y="5310967"/>
              <a:ext cx="2790991" cy="182347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48027" y="7241053"/>
              <a:ext cx="2790991" cy="182347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10447" y="7241053"/>
              <a:ext cx="2790991" cy="182347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48028" y="5310967"/>
              <a:ext cx="2790991" cy="1823472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1156708" y="4390717"/>
            <a:ext cx="2267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Plasmid 1 DNA position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158427" y="909175"/>
            <a:ext cx="6254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400" b="1" dirty="0" err="1" smtClean="0"/>
              <a:t>Crude</a:t>
            </a:r>
            <a:endParaRPr lang="fr-CH" sz="1400" b="1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1114119" y="2456431"/>
            <a:ext cx="3338119" cy="213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 smtClean="0"/>
              <a:t>Standard deviation</a:t>
            </a:r>
            <a:endParaRPr lang="fr-CH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835190" y="909175"/>
            <a:ext cx="6254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400" b="1" dirty="0" err="1" smtClean="0"/>
              <a:t>Crude</a:t>
            </a:r>
            <a:endParaRPr lang="fr-CH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834942" y="2735361"/>
            <a:ext cx="487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400" b="1" dirty="0" smtClean="0"/>
              <a:t>RCA</a:t>
            </a:r>
            <a:endParaRPr lang="fr-CH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1155967" y="2735361"/>
            <a:ext cx="487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400" b="1" dirty="0" smtClean="0"/>
              <a:t>RCA</a:t>
            </a:r>
            <a:endParaRPr lang="fr-CH" sz="1400" b="1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738062" y="894295"/>
            <a:ext cx="0" cy="333811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5124434" y="3114653"/>
            <a:ext cx="10942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b="1" dirty="0" smtClean="0">
                <a:solidFill>
                  <a:srgbClr val="FF0000"/>
                </a:solidFill>
              </a:rPr>
              <a:t>Position 1’645</a:t>
            </a:r>
          </a:p>
          <a:p>
            <a:r>
              <a:rPr lang="fr-CH" sz="1200" b="1" dirty="0" smtClean="0">
                <a:solidFill>
                  <a:srgbClr val="FF0000"/>
                </a:solidFill>
              </a:rPr>
              <a:t>0.9%</a:t>
            </a:r>
            <a:endParaRPr lang="fr-CH" sz="1200" b="1" dirty="0">
              <a:solidFill>
                <a:srgbClr val="FF000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96600" y="3114653"/>
            <a:ext cx="10942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CH" sz="1200" b="1" dirty="0" smtClean="0">
                <a:solidFill>
                  <a:srgbClr val="FF0000"/>
                </a:solidFill>
              </a:rPr>
              <a:t>Position 4’152</a:t>
            </a:r>
          </a:p>
          <a:p>
            <a:pPr algn="r"/>
            <a:r>
              <a:rPr lang="fr-CH" sz="1200" b="1" dirty="0" smtClean="0">
                <a:solidFill>
                  <a:srgbClr val="FF0000"/>
                </a:solidFill>
              </a:rPr>
              <a:t>2.3%</a:t>
            </a:r>
            <a:endParaRPr lang="fr-CH" sz="1200" b="1" dirty="0">
              <a:solidFill>
                <a:srgbClr val="FF0000"/>
              </a:solidFill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 rot="10800000" flipH="1">
            <a:off x="2838379" y="3263977"/>
            <a:ext cx="193203" cy="403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1156708" y="4392503"/>
            <a:ext cx="2268000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3846568" y="4390717"/>
            <a:ext cx="2267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Plasmid 2 DNA position</a:t>
            </a:r>
            <a:endParaRPr lang="en-US" sz="1400" b="1" dirty="0"/>
          </a:p>
        </p:txBody>
      </p:sp>
      <p:cxnSp>
        <p:nvCxnSpPr>
          <p:cNvPr id="33" name="Straight Arrow Connector 32"/>
          <p:cNvCxnSpPr/>
          <p:nvPr/>
        </p:nvCxnSpPr>
        <p:spPr>
          <a:xfrm>
            <a:off x="3846568" y="4392503"/>
            <a:ext cx="2268000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 flipH="1">
            <a:off x="4987979" y="3271597"/>
            <a:ext cx="193203" cy="403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811608" y="5302252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200" b="1" dirty="0" smtClean="0"/>
              <a:t>Plasmid1</a:t>
            </a:r>
            <a:endParaRPr lang="fr-CH" sz="12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811608" y="5494438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200" b="1" dirty="0" smtClean="0"/>
              <a:t>Plasmid2</a:t>
            </a:r>
            <a:endParaRPr lang="fr-CH" sz="12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811838" y="5110065"/>
            <a:ext cx="764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200" b="1" dirty="0" smtClean="0"/>
              <a:t>NTC </a:t>
            </a:r>
            <a:r>
              <a:rPr lang="fr-CH" sz="1200" b="1" dirty="0" err="1" smtClean="0"/>
              <a:t>read</a:t>
            </a:r>
            <a:endParaRPr lang="fr-CH" sz="1200" b="1" dirty="0"/>
          </a:p>
        </p:txBody>
      </p:sp>
      <p:grpSp>
        <p:nvGrpSpPr>
          <p:cNvPr id="43" name="Group 42"/>
          <p:cNvGrpSpPr/>
          <p:nvPr/>
        </p:nvGrpSpPr>
        <p:grpSpPr>
          <a:xfrm>
            <a:off x="1527765" y="5078314"/>
            <a:ext cx="4621486" cy="738285"/>
            <a:chOff x="1369739" y="5067872"/>
            <a:chExt cx="4773302" cy="601127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7"/>
            <a:srcRect l="8154" r="3148"/>
            <a:stretch/>
          </p:blipFill>
          <p:spPr>
            <a:xfrm>
              <a:off x="1369739" y="5067872"/>
              <a:ext cx="4773302" cy="601127"/>
            </a:xfrm>
            <a:prstGeom prst="rect">
              <a:avLst/>
            </a:prstGeom>
          </p:spPr>
        </p:pic>
        <p:sp>
          <p:nvSpPr>
            <p:cNvPr id="40" name="Rectangle 39"/>
            <p:cNvSpPr/>
            <p:nvPr/>
          </p:nvSpPr>
          <p:spPr>
            <a:xfrm>
              <a:off x="3665152" y="5099003"/>
              <a:ext cx="144799" cy="51801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4" name="TextBox 43"/>
          <p:cNvSpPr txBox="1"/>
          <p:nvPr/>
        </p:nvSpPr>
        <p:spPr>
          <a:xfrm>
            <a:off x="275470" y="716669"/>
            <a:ext cx="454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2400" b="1" dirty="0" smtClean="0"/>
              <a:t>A.</a:t>
            </a:r>
            <a:endParaRPr lang="fr-CH" sz="24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275470" y="4994007"/>
            <a:ext cx="4395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2400" b="1" dirty="0" smtClean="0"/>
              <a:t>B.</a:t>
            </a:r>
            <a:endParaRPr lang="fr-CH" sz="2400" b="1" dirty="0"/>
          </a:p>
        </p:txBody>
      </p:sp>
    </p:spTree>
    <p:extLst>
      <p:ext uri="{BB962C8B-B14F-4D97-AF65-F5344CB8AC3E}">
        <p14:creationId xmlns:p14="http://schemas.microsoft.com/office/powerpoint/2010/main" val="1026836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9</TotalTime>
  <Words>31</Words>
  <Application>Microsoft Office PowerPoint</Application>
  <PresentationFormat>A4 Paper (210x297 mm)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estl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quis,Julien,LAUSANNE,Functional Genomics</dc:creator>
  <cp:lastModifiedBy>Marquis,Julien,LAUSANNE,Functional Genomics</cp:lastModifiedBy>
  <cp:revision>37</cp:revision>
  <cp:lastPrinted>2016-01-06T12:41:26Z</cp:lastPrinted>
  <dcterms:created xsi:type="dcterms:W3CDTF">2016-01-06T07:21:02Z</dcterms:created>
  <dcterms:modified xsi:type="dcterms:W3CDTF">2016-03-11T16:44:07Z</dcterms:modified>
</cp:coreProperties>
</file>